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M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566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341"/>
    <p:restoredTop sz="94635"/>
  </p:normalViewPr>
  <p:slideViewPr>
    <p:cSldViewPr snapToGrid="0" showGuides="1">
      <p:cViewPr varScale="1">
        <p:scale>
          <a:sx n="105" d="100"/>
          <a:sy n="105" d="100"/>
        </p:scale>
        <p:origin x="440" y="192"/>
      </p:cViewPr>
      <p:guideLst>
        <p:guide orient="horz" pos="3566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MZ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34F57F-BA61-774E-BF09-D702B878A32F}" type="datetimeFigureOut">
              <a:rPr lang="en-MZ" smtClean="0"/>
              <a:t>26/02/25</a:t>
            </a:fld>
            <a:endParaRPr lang="en-MZ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MZ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M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2B77BF-816A-1A40-A4EA-4F634C274378}" type="slidenum">
              <a:rPr lang="en-MZ" smtClean="0"/>
              <a:t>‹#›</a:t>
            </a:fld>
            <a:endParaRPr lang="en-MZ"/>
          </a:p>
        </p:txBody>
      </p:sp>
    </p:spTree>
    <p:extLst>
      <p:ext uri="{BB962C8B-B14F-4D97-AF65-F5344CB8AC3E}">
        <p14:creationId xmlns:p14="http://schemas.microsoft.com/office/powerpoint/2010/main" val="35047169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MZ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F2B77BF-816A-1A40-A4EA-4F634C274378}" type="slidenum">
              <a:rPr lang="en-MZ" smtClean="0"/>
              <a:t>1</a:t>
            </a:fld>
            <a:endParaRPr lang="en-MZ"/>
          </a:p>
        </p:txBody>
      </p:sp>
    </p:spTree>
    <p:extLst>
      <p:ext uri="{BB962C8B-B14F-4D97-AF65-F5344CB8AC3E}">
        <p14:creationId xmlns:p14="http://schemas.microsoft.com/office/powerpoint/2010/main" val="11845138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ED96C4-D2EC-D72E-152D-D99B29A90E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MZ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60753FE-EB12-F55A-3C15-6E308FBF6F3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M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425526-B230-C54A-002D-2133C03A4A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42275-8388-FF4C-956B-7D240D167E22}" type="datetimeFigureOut">
              <a:rPr lang="en-MZ" smtClean="0"/>
              <a:t>26/02/25</a:t>
            </a:fld>
            <a:endParaRPr lang="en-M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3C3C4E-DD32-E70C-FF40-C0A8126798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2B34D6-3368-2555-E984-F53D352C6F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F30528-6499-2A4E-930F-E225343FF768}" type="slidenum">
              <a:rPr lang="en-MZ" smtClean="0"/>
              <a:t>‹#›</a:t>
            </a:fld>
            <a:endParaRPr lang="en-MZ"/>
          </a:p>
        </p:txBody>
      </p:sp>
    </p:spTree>
    <p:extLst>
      <p:ext uri="{BB962C8B-B14F-4D97-AF65-F5344CB8AC3E}">
        <p14:creationId xmlns:p14="http://schemas.microsoft.com/office/powerpoint/2010/main" val="38216203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E559D6-CC62-3432-A1E5-6E73AFB8DC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MZ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8B4DC0B-7D6E-5379-927B-A3C31F027C2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6388A2-1B5F-C809-94A2-D98DC5922F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42275-8388-FF4C-956B-7D240D167E22}" type="datetimeFigureOut">
              <a:rPr lang="en-MZ" smtClean="0"/>
              <a:t>26/02/25</a:t>
            </a:fld>
            <a:endParaRPr lang="en-M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F012E9-BB3F-8CE1-2C1F-671DA503A6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379F5F-7EBD-EDDE-9BFC-179A64568F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F30528-6499-2A4E-930F-E225343FF768}" type="slidenum">
              <a:rPr lang="en-MZ" smtClean="0"/>
              <a:t>‹#›</a:t>
            </a:fld>
            <a:endParaRPr lang="en-MZ"/>
          </a:p>
        </p:txBody>
      </p:sp>
    </p:spTree>
    <p:extLst>
      <p:ext uri="{BB962C8B-B14F-4D97-AF65-F5344CB8AC3E}">
        <p14:creationId xmlns:p14="http://schemas.microsoft.com/office/powerpoint/2010/main" val="30911533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54F24AC-26ED-D5D3-57BB-90D26E2E812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MZ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9C60DE6-A333-0D42-C18C-30DE27FD474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EE951B-D196-4B13-D0A7-EEEE6A9010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42275-8388-FF4C-956B-7D240D167E22}" type="datetimeFigureOut">
              <a:rPr lang="en-MZ" smtClean="0"/>
              <a:t>26/02/25</a:t>
            </a:fld>
            <a:endParaRPr lang="en-M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51C138-E1F6-F7AB-80D1-2EEEF36920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FFCE73-078E-916D-61AB-6AEF764084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F30528-6499-2A4E-930F-E225343FF768}" type="slidenum">
              <a:rPr lang="en-MZ" smtClean="0"/>
              <a:t>‹#›</a:t>
            </a:fld>
            <a:endParaRPr lang="en-MZ"/>
          </a:p>
        </p:txBody>
      </p:sp>
    </p:spTree>
    <p:extLst>
      <p:ext uri="{BB962C8B-B14F-4D97-AF65-F5344CB8AC3E}">
        <p14:creationId xmlns:p14="http://schemas.microsoft.com/office/powerpoint/2010/main" val="24646664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E29523-6932-E8B1-B055-81A2F95C16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MZ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0B98A26-D120-6687-D5AC-301EF8A5BD4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04EB8F-10AA-50BE-B7D3-F561F9B7A5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42275-8388-FF4C-956B-7D240D167E22}" type="datetimeFigureOut">
              <a:rPr lang="en-MZ" smtClean="0"/>
              <a:t>26/02/25</a:t>
            </a:fld>
            <a:endParaRPr lang="en-M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77FA76-A262-6F4A-DE6F-87AC8DB35B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6F905F-837D-C679-9C5F-3ACC67E0EC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F30528-6499-2A4E-930F-E225343FF768}" type="slidenum">
              <a:rPr lang="en-MZ" smtClean="0"/>
              <a:t>‹#›</a:t>
            </a:fld>
            <a:endParaRPr lang="en-MZ"/>
          </a:p>
        </p:txBody>
      </p:sp>
    </p:spTree>
    <p:extLst>
      <p:ext uri="{BB962C8B-B14F-4D97-AF65-F5344CB8AC3E}">
        <p14:creationId xmlns:p14="http://schemas.microsoft.com/office/powerpoint/2010/main" val="851606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E9EEC9-6EB5-69E4-46AD-4647C8D4C8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MZ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2530281-FC72-AC60-223F-01E851E29B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C3BA56-BADE-8AD1-E8B4-357D718D27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42275-8388-FF4C-956B-7D240D167E22}" type="datetimeFigureOut">
              <a:rPr lang="en-MZ" smtClean="0"/>
              <a:t>26/02/25</a:t>
            </a:fld>
            <a:endParaRPr lang="en-M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C36E50-3916-9ADF-23B3-062F34FD78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2B8C8A-6D6A-4841-5FEB-EF704CD7FF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F30528-6499-2A4E-930F-E225343FF768}" type="slidenum">
              <a:rPr lang="en-MZ" smtClean="0"/>
              <a:t>‹#›</a:t>
            </a:fld>
            <a:endParaRPr lang="en-MZ"/>
          </a:p>
        </p:txBody>
      </p:sp>
    </p:spTree>
    <p:extLst>
      <p:ext uri="{BB962C8B-B14F-4D97-AF65-F5344CB8AC3E}">
        <p14:creationId xmlns:p14="http://schemas.microsoft.com/office/powerpoint/2010/main" val="31293288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8C814B-D49F-617C-5787-25905D86E9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MZ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588ECFA-AA5C-B1FE-BA2E-8ADD99547B3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Z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9D0A42A-6083-8B28-348A-7DF8DDD496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Z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59B90E6-4372-036D-88C1-B33DB062B8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42275-8388-FF4C-956B-7D240D167E22}" type="datetimeFigureOut">
              <a:rPr lang="en-MZ" smtClean="0"/>
              <a:t>26/02/25</a:t>
            </a:fld>
            <a:endParaRPr lang="en-MZ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4EC1BA-2E57-6D9C-81E3-DC03C0A2B4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Z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34A1F3A-C7B1-0A77-4BA9-781A6C21DC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F30528-6499-2A4E-930F-E225343FF768}" type="slidenum">
              <a:rPr lang="en-MZ" smtClean="0"/>
              <a:t>‹#›</a:t>
            </a:fld>
            <a:endParaRPr lang="en-MZ"/>
          </a:p>
        </p:txBody>
      </p:sp>
    </p:spTree>
    <p:extLst>
      <p:ext uri="{BB962C8B-B14F-4D97-AF65-F5344CB8AC3E}">
        <p14:creationId xmlns:p14="http://schemas.microsoft.com/office/powerpoint/2010/main" val="41762326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3B484B-CF4B-8615-8879-79B5C3309B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MZ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3592A4F-0B24-5292-F11D-B57293399D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84A477C-97C4-9419-19F1-28C79EEAF1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Z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AB57266-0C38-D2FB-5E9F-D623249CE70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96CD828-FFF7-2147-A0E3-11360BA103F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Z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A7590D0-F51B-7821-17CB-537179F1ED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42275-8388-FF4C-956B-7D240D167E22}" type="datetimeFigureOut">
              <a:rPr lang="en-MZ" smtClean="0"/>
              <a:t>26/02/25</a:t>
            </a:fld>
            <a:endParaRPr lang="en-MZ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7367B47-731C-0712-C40A-05C012B6D9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Z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EF1814E-244C-97A0-3680-7EEA319845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F30528-6499-2A4E-930F-E225343FF768}" type="slidenum">
              <a:rPr lang="en-MZ" smtClean="0"/>
              <a:t>‹#›</a:t>
            </a:fld>
            <a:endParaRPr lang="en-MZ"/>
          </a:p>
        </p:txBody>
      </p:sp>
    </p:spTree>
    <p:extLst>
      <p:ext uri="{BB962C8B-B14F-4D97-AF65-F5344CB8AC3E}">
        <p14:creationId xmlns:p14="http://schemas.microsoft.com/office/powerpoint/2010/main" val="10685250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C5827B-289F-C78B-F79D-5671EED543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MZ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59648B0-AA43-6986-AE87-FEFD65D047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42275-8388-FF4C-956B-7D240D167E22}" type="datetimeFigureOut">
              <a:rPr lang="en-MZ" smtClean="0"/>
              <a:t>26/02/25</a:t>
            </a:fld>
            <a:endParaRPr lang="en-MZ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BA92048-3B1B-3EBC-331E-AE32853820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Z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DD2F7E1-DC49-B38D-943C-B1B07494F7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F30528-6499-2A4E-930F-E225343FF768}" type="slidenum">
              <a:rPr lang="en-MZ" smtClean="0"/>
              <a:t>‹#›</a:t>
            </a:fld>
            <a:endParaRPr lang="en-MZ"/>
          </a:p>
        </p:txBody>
      </p:sp>
    </p:spTree>
    <p:extLst>
      <p:ext uri="{BB962C8B-B14F-4D97-AF65-F5344CB8AC3E}">
        <p14:creationId xmlns:p14="http://schemas.microsoft.com/office/powerpoint/2010/main" val="2139688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E14B896-5476-F1CC-AA92-A5B9804DE3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42275-8388-FF4C-956B-7D240D167E22}" type="datetimeFigureOut">
              <a:rPr lang="en-MZ" smtClean="0"/>
              <a:t>26/02/25</a:t>
            </a:fld>
            <a:endParaRPr lang="en-MZ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665FF83-01E0-38AA-040F-5B048F15CC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Z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F1CAB48-F365-42AF-B20C-6B52B770F1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F30528-6499-2A4E-930F-E225343FF768}" type="slidenum">
              <a:rPr lang="en-MZ" smtClean="0"/>
              <a:t>‹#›</a:t>
            </a:fld>
            <a:endParaRPr lang="en-MZ"/>
          </a:p>
        </p:txBody>
      </p:sp>
    </p:spTree>
    <p:extLst>
      <p:ext uri="{BB962C8B-B14F-4D97-AF65-F5344CB8AC3E}">
        <p14:creationId xmlns:p14="http://schemas.microsoft.com/office/powerpoint/2010/main" val="29991873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9B85A3-1D01-3DAE-BC59-39782C1175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MZ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E2167E8-6CDE-769F-AE19-BE01E35A7E7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Z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0A96FFB-7632-0984-4F36-38A4FCDB7A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491B54-0A82-F504-5A24-9B6289A653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42275-8388-FF4C-956B-7D240D167E22}" type="datetimeFigureOut">
              <a:rPr lang="en-MZ" smtClean="0"/>
              <a:t>26/02/25</a:t>
            </a:fld>
            <a:endParaRPr lang="en-MZ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83A3DF-B5FD-E3AE-0A64-FF7D97F0E9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Z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96BF156-139E-C6D5-84D0-7F1DB1660F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F30528-6499-2A4E-930F-E225343FF768}" type="slidenum">
              <a:rPr lang="en-MZ" smtClean="0"/>
              <a:t>‹#›</a:t>
            </a:fld>
            <a:endParaRPr lang="en-MZ"/>
          </a:p>
        </p:txBody>
      </p:sp>
    </p:spTree>
    <p:extLst>
      <p:ext uri="{BB962C8B-B14F-4D97-AF65-F5344CB8AC3E}">
        <p14:creationId xmlns:p14="http://schemas.microsoft.com/office/powerpoint/2010/main" val="5216094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9711E8-8339-6059-2120-C0E8CF13F4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MZ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15D2828-1FD6-D0F7-575C-80A6FBD596B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MZ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733DD0A-E884-F97F-1714-65E07AD4B6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A29E95-6629-8FD8-7669-2D33ADA7E5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42275-8388-FF4C-956B-7D240D167E22}" type="datetimeFigureOut">
              <a:rPr lang="en-MZ" smtClean="0"/>
              <a:t>26/02/25</a:t>
            </a:fld>
            <a:endParaRPr lang="en-MZ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8D8F02-B523-1F32-C9E2-AEDF6A89C5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Z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CE28515-B39C-667B-416C-98A4991DFE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F30528-6499-2A4E-930F-E225343FF768}" type="slidenum">
              <a:rPr lang="en-MZ" smtClean="0"/>
              <a:t>‹#›</a:t>
            </a:fld>
            <a:endParaRPr lang="en-MZ"/>
          </a:p>
        </p:txBody>
      </p:sp>
    </p:spTree>
    <p:extLst>
      <p:ext uri="{BB962C8B-B14F-4D97-AF65-F5344CB8AC3E}">
        <p14:creationId xmlns:p14="http://schemas.microsoft.com/office/powerpoint/2010/main" val="27300161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C1A5220-FE0A-2C2E-7470-3BF62F49E1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MZ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D52F0AC-97CF-19DE-2E39-A82DD1F3B0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0A7B0A-F795-B697-1087-DA0DF2F3CA0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A542275-8388-FF4C-956B-7D240D167E22}" type="datetimeFigureOut">
              <a:rPr lang="en-MZ" smtClean="0"/>
              <a:t>26/02/25</a:t>
            </a:fld>
            <a:endParaRPr lang="en-M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52A84B-21D3-2A34-C134-5C03CE15996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M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A154AE-D9FE-0836-633D-6EEDD66DC9B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7F30528-6499-2A4E-930F-E225343FF768}" type="slidenum">
              <a:rPr lang="en-MZ" smtClean="0"/>
              <a:t>‹#›</a:t>
            </a:fld>
            <a:endParaRPr lang="en-MZ"/>
          </a:p>
        </p:txBody>
      </p:sp>
    </p:spTree>
    <p:extLst>
      <p:ext uri="{BB962C8B-B14F-4D97-AF65-F5344CB8AC3E}">
        <p14:creationId xmlns:p14="http://schemas.microsoft.com/office/powerpoint/2010/main" val="40595822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M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AF5E7EBE-2EFE-C80D-95FB-FBA28467E635}"/>
              </a:ext>
            </a:extLst>
          </p:cNvPr>
          <p:cNvSpPr txBox="1"/>
          <p:nvPr/>
        </p:nvSpPr>
        <p:spPr>
          <a:xfrm>
            <a:off x="3956478" y="2862670"/>
            <a:ext cx="10607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Z" sz="1400" b="1" dirty="0"/>
              <a:t>S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3EAB37B-2ED3-BECD-1333-34A8D06B71D7}"/>
              </a:ext>
            </a:extLst>
          </p:cNvPr>
          <p:cNvSpPr txBox="1"/>
          <p:nvPr/>
        </p:nvSpPr>
        <p:spPr>
          <a:xfrm>
            <a:off x="6776033" y="2869813"/>
            <a:ext cx="10607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Z" sz="1400" b="1" dirty="0"/>
              <a:t>SP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E0EA2735-9F3A-5881-1303-2FCB976A707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93605" y="242800"/>
            <a:ext cx="3804790" cy="2563348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6CC8E555-6179-AC98-D21C-473D44A5BF1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95076" y="3241255"/>
            <a:ext cx="3089436" cy="3547525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BDDDA1D5-757A-BE34-460C-736AA0269E8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29867" y="3298543"/>
            <a:ext cx="3485026" cy="348502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D77098B-AD47-FE50-85AE-692A44D3FA3D}"/>
              </a:ext>
            </a:extLst>
          </p:cNvPr>
          <p:cNvSpPr txBox="1"/>
          <p:nvPr/>
        </p:nvSpPr>
        <p:spPr>
          <a:xfrm>
            <a:off x="8984512" y="1079938"/>
            <a:ext cx="3027305" cy="20905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tabLst>
                <a:tab pos="660400" algn="l"/>
              </a:tabLst>
            </a:pPr>
            <a:r>
              <a:rPr lang="en-MZ" sz="1800" b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 </a:t>
            </a:r>
          </a:p>
          <a:p>
            <a:pPr>
              <a:lnSpc>
                <a:spcPct val="115000"/>
              </a:lnSpc>
              <a:spcAft>
                <a:spcPts val="800"/>
              </a:spcAft>
              <a:tabLst>
                <a:tab pos="660400" algn="l"/>
              </a:tabLst>
            </a:pPr>
            <a:r>
              <a:rPr lang="en-MZ" sz="1800" b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rincipal component analysis of antibody response and correlation matrix in seropositive and seronegative groups.</a:t>
            </a:r>
          </a:p>
        </p:txBody>
      </p:sp>
    </p:spTree>
    <p:extLst>
      <p:ext uri="{BB962C8B-B14F-4D97-AF65-F5344CB8AC3E}">
        <p14:creationId xmlns:p14="http://schemas.microsoft.com/office/powerpoint/2010/main" val="36946787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015</TotalTime>
  <Words>19</Words>
  <Application>Microsoft Macintosh PowerPoint</Application>
  <PresentationFormat>Widescreen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aquel Matavele</dc:creator>
  <cp:lastModifiedBy>Raquel Matavele</cp:lastModifiedBy>
  <cp:revision>11</cp:revision>
  <dcterms:created xsi:type="dcterms:W3CDTF">2025-02-21T09:13:21Z</dcterms:created>
  <dcterms:modified xsi:type="dcterms:W3CDTF">2025-02-26T08:23:32Z</dcterms:modified>
</cp:coreProperties>
</file>